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6" r:id="rId2"/>
  </p:sldIdLst>
  <p:sldSz cx="5759450" cy="2160588"/>
  <p:notesSz cx="6858000" cy="9144000"/>
  <p:defaultTextStyle>
    <a:defPPr>
      <a:defRPr lang="zh-CN"/>
    </a:defPPr>
    <a:lvl1pPr marL="0" algn="l" defTabSz="414719" rtl="0" eaLnBrk="1" latinLnBrk="0" hangingPunct="1">
      <a:defRPr sz="816" kern="1200">
        <a:solidFill>
          <a:schemeClr val="tx1"/>
        </a:solidFill>
        <a:latin typeface="+mn-lt"/>
        <a:ea typeface="+mn-ea"/>
        <a:cs typeface="+mn-cs"/>
      </a:defRPr>
    </a:lvl1pPr>
    <a:lvl2pPr marL="207360" algn="l" defTabSz="414719" rtl="0" eaLnBrk="1" latinLnBrk="0" hangingPunct="1">
      <a:defRPr sz="816" kern="1200">
        <a:solidFill>
          <a:schemeClr val="tx1"/>
        </a:solidFill>
        <a:latin typeface="+mn-lt"/>
        <a:ea typeface="+mn-ea"/>
        <a:cs typeface="+mn-cs"/>
      </a:defRPr>
    </a:lvl2pPr>
    <a:lvl3pPr marL="414719" algn="l" defTabSz="414719" rtl="0" eaLnBrk="1" latinLnBrk="0" hangingPunct="1">
      <a:defRPr sz="816" kern="1200">
        <a:solidFill>
          <a:schemeClr val="tx1"/>
        </a:solidFill>
        <a:latin typeface="+mn-lt"/>
        <a:ea typeface="+mn-ea"/>
        <a:cs typeface="+mn-cs"/>
      </a:defRPr>
    </a:lvl3pPr>
    <a:lvl4pPr marL="622079" algn="l" defTabSz="414719" rtl="0" eaLnBrk="1" latinLnBrk="0" hangingPunct="1">
      <a:defRPr sz="816" kern="1200">
        <a:solidFill>
          <a:schemeClr val="tx1"/>
        </a:solidFill>
        <a:latin typeface="+mn-lt"/>
        <a:ea typeface="+mn-ea"/>
        <a:cs typeface="+mn-cs"/>
      </a:defRPr>
    </a:lvl4pPr>
    <a:lvl5pPr marL="829439" algn="l" defTabSz="414719" rtl="0" eaLnBrk="1" latinLnBrk="0" hangingPunct="1">
      <a:defRPr sz="816" kern="1200">
        <a:solidFill>
          <a:schemeClr val="tx1"/>
        </a:solidFill>
        <a:latin typeface="+mn-lt"/>
        <a:ea typeface="+mn-ea"/>
        <a:cs typeface="+mn-cs"/>
      </a:defRPr>
    </a:lvl5pPr>
    <a:lvl6pPr marL="1036798" algn="l" defTabSz="414719" rtl="0" eaLnBrk="1" latinLnBrk="0" hangingPunct="1">
      <a:defRPr sz="816" kern="1200">
        <a:solidFill>
          <a:schemeClr val="tx1"/>
        </a:solidFill>
        <a:latin typeface="+mn-lt"/>
        <a:ea typeface="+mn-ea"/>
        <a:cs typeface="+mn-cs"/>
      </a:defRPr>
    </a:lvl6pPr>
    <a:lvl7pPr marL="1244158" algn="l" defTabSz="414719" rtl="0" eaLnBrk="1" latinLnBrk="0" hangingPunct="1">
      <a:defRPr sz="816" kern="1200">
        <a:solidFill>
          <a:schemeClr val="tx1"/>
        </a:solidFill>
        <a:latin typeface="+mn-lt"/>
        <a:ea typeface="+mn-ea"/>
        <a:cs typeface="+mn-cs"/>
      </a:defRPr>
    </a:lvl7pPr>
    <a:lvl8pPr marL="1451517" algn="l" defTabSz="414719" rtl="0" eaLnBrk="1" latinLnBrk="0" hangingPunct="1">
      <a:defRPr sz="816" kern="1200">
        <a:solidFill>
          <a:schemeClr val="tx1"/>
        </a:solidFill>
        <a:latin typeface="+mn-lt"/>
        <a:ea typeface="+mn-ea"/>
        <a:cs typeface="+mn-cs"/>
      </a:defRPr>
    </a:lvl8pPr>
    <a:lvl9pPr marL="1658877" algn="l" defTabSz="414719" rtl="0" eaLnBrk="1" latinLnBrk="0" hangingPunct="1">
      <a:defRPr sz="81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81" userDrawn="1">
          <p15:clr>
            <a:srgbClr val="A4A3A4"/>
          </p15:clr>
        </p15:guide>
        <p15:guide id="2" pos="181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5242"/>
  </p:normalViewPr>
  <p:slideViewPr>
    <p:cSldViewPr snapToGrid="0" snapToObjects="1" showGuides="1">
      <p:cViewPr>
        <p:scale>
          <a:sx n="92" d="100"/>
          <a:sy n="92" d="100"/>
        </p:scale>
        <p:origin x="2544" y="1480"/>
      </p:cViewPr>
      <p:guideLst>
        <p:guide orient="horz" pos="681"/>
        <p:guide pos="181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19931" y="353596"/>
            <a:ext cx="4319588" cy="752205"/>
          </a:xfrm>
        </p:spPr>
        <p:txBody>
          <a:bodyPr anchor="b"/>
          <a:lstStyle>
            <a:lvl1pPr algn="ctr">
              <a:defRPr sz="189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19931" y="1134809"/>
            <a:ext cx="4319588" cy="521642"/>
          </a:xfrm>
        </p:spPr>
        <p:txBody>
          <a:bodyPr/>
          <a:lstStyle>
            <a:lvl1pPr marL="0" indent="0" algn="ctr">
              <a:buNone/>
              <a:defRPr sz="756"/>
            </a:lvl1pPr>
            <a:lvl2pPr marL="144018" indent="0" algn="ctr">
              <a:buNone/>
              <a:defRPr sz="630"/>
            </a:lvl2pPr>
            <a:lvl3pPr marL="288036" indent="0" algn="ctr">
              <a:buNone/>
              <a:defRPr sz="567"/>
            </a:lvl3pPr>
            <a:lvl4pPr marL="432054" indent="0" algn="ctr">
              <a:buNone/>
              <a:defRPr sz="504"/>
            </a:lvl4pPr>
            <a:lvl5pPr marL="576072" indent="0" algn="ctr">
              <a:buNone/>
              <a:defRPr sz="504"/>
            </a:lvl5pPr>
            <a:lvl6pPr marL="720090" indent="0" algn="ctr">
              <a:buNone/>
              <a:defRPr sz="504"/>
            </a:lvl6pPr>
            <a:lvl7pPr marL="864108" indent="0" algn="ctr">
              <a:buNone/>
              <a:defRPr sz="504"/>
            </a:lvl7pPr>
            <a:lvl8pPr marL="1008126" indent="0" algn="ctr">
              <a:buNone/>
              <a:defRPr sz="504"/>
            </a:lvl8pPr>
            <a:lvl9pPr marL="1152144" indent="0" algn="ctr">
              <a:buNone/>
              <a:defRPr sz="504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089A3-F22B-0A4E-8A87-485EF8273370}" type="datetimeFigureOut">
              <a:rPr kumimoji="1" lang="zh-CN" altLang="en-US" smtClean="0"/>
              <a:t>2018/9/8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95EF27-9A66-A148-9307-9C9E776C768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922056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089A3-F22B-0A4E-8A87-485EF8273370}" type="datetimeFigureOut">
              <a:rPr kumimoji="1" lang="zh-CN" altLang="en-US" smtClean="0"/>
              <a:t>2018/9/8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95EF27-9A66-A148-9307-9C9E776C768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987503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121607" y="115032"/>
            <a:ext cx="1241881" cy="183099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95962" y="115032"/>
            <a:ext cx="3653651" cy="183099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089A3-F22B-0A4E-8A87-485EF8273370}" type="datetimeFigureOut">
              <a:rPr kumimoji="1" lang="zh-CN" altLang="en-US" smtClean="0"/>
              <a:t>2018/9/8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95EF27-9A66-A148-9307-9C9E776C768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686767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089A3-F22B-0A4E-8A87-485EF8273370}" type="datetimeFigureOut">
              <a:rPr kumimoji="1" lang="zh-CN" altLang="en-US" smtClean="0"/>
              <a:t>2018/9/8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95EF27-9A66-A148-9307-9C9E776C768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77714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2962" y="538647"/>
            <a:ext cx="4967526" cy="898744"/>
          </a:xfrm>
        </p:spPr>
        <p:txBody>
          <a:bodyPr anchor="b"/>
          <a:lstStyle>
            <a:lvl1pPr>
              <a:defRPr sz="189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2962" y="1445894"/>
            <a:ext cx="4967526" cy="472628"/>
          </a:xfrm>
        </p:spPr>
        <p:txBody>
          <a:bodyPr/>
          <a:lstStyle>
            <a:lvl1pPr marL="0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1pPr>
            <a:lvl2pPr marL="144018" indent="0">
              <a:buNone/>
              <a:defRPr sz="630">
                <a:solidFill>
                  <a:schemeClr val="tx1">
                    <a:tint val="75000"/>
                  </a:schemeClr>
                </a:solidFill>
              </a:defRPr>
            </a:lvl2pPr>
            <a:lvl3pPr marL="288036" indent="0">
              <a:buNone/>
              <a:defRPr sz="567">
                <a:solidFill>
                  <a:schemeClr val="tx1">
                    <a:tint val="75000"/>
                  </a:schemeClr>
                </a:solidFill>
              </a:defRPr>
            </a:lvl3pPr>
            <a:lvl4pPr marL="432054" indent="0">
              <a:buNone/>
              <a:defRPr sz="504">
                <a:solidFill>
                  <a:schemeClr val="tx1">
                    <a:tint val="75000"/>
                  </a:schemeClr>
                </a:solidFill>
              </a:defRPr>
            </a:lvl4pPr>
            <a:lvl5pPr marL="576072" indent="0">
              <a:buNone/>
              <a:defRPr sz="504">
                <a:solidFill>
                  <a:schemeClr val="tx1">
                    <a:tint val="75000"/>
                  </a:schemeClr>
                </a:solidFill>
              </a:defRPr>
            </a:lvl5pPr>
            <a:lvl6pPr marL="720090" indent="0">
              <a:buNone/>
              <a:defRPr sz="504">
                <a:solidFill>
                  <a:schemeClr val="tx1">
                    <a:tint val="75000"/>
                  </a:schemeClr>
                </a:solidFill>
              </a:defRPr>
            </a:lvl6pPr>
            <a:lvl7pPr marL="864108" indent="0">
              <a:buNone/>
              <a:defRPr sz="504">
                <a:solidFill>
                  <a:schemeClr val="tx1">
                    <a:tint val="75000"/>
                  </a:schemeClr>
                </a:solidFill>
              </a:defRPr>
            </a:lvl7pPr>
            <a:lvl8pPr marL="1008126" indent="0">
              <a:buNone/>
              <a:defRPr sz="504">
                <a:solidFill>
                  <a:schemeClr val="tx1">
                    <a:tint val="75000"/>
                  </a:schemeClr>
                </a:solidFill>
              </a:defRPr>
            </a:lvl8pPr>
            <a:lvl9pPr marL="1152144" indent="0">
              <a:buNone/>
              <a:defRPr sz="50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089A3-F22B-0A4E-8A87-485EF8273370}" type="datetimeFigureOut">
              <a:rPr kumimoji="1" lang="zh-CN" altLang="en-US" smtClean="0"/>
              <a:t>2018/9/8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95EF27-9A66-A148-9307-9C9E776C768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79743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95962" y="575157"/>
            <a:ext cx="2447766" cy="137087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15722" y="575157"/>
            <a:ext cx="2447766" cy="137087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089A3-F22B-0A4E-8A87-485EF8273370}" type="datetimeFigureOut">
              <a:rPr kumimoji="1" lang="zh-CN" altLang="en-US" smtClean="0"/>
              <a:t>2018/9/8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95EF27-9A66-A148-9307-9C9E776C768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052796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2" y="115031"/>
            <a:ext cx="4967526" cy="417614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6713" y="529645"/>
            <a:ext cx="2436517" cy="259570"/>
          </a:xfrm>
        </p:spPr>
        <p:txBody>
          <a:bodyPr anchor="b"/>
          <a:lstStyle>
            <a:lvl1pPr marL="0" indent="0">
              <a:buNone/>
              <a:defRPr sz="756" b="1"/>
            </a:lvl1pPr>
            <a:lvl2pPr marL="144018" indent="0">
              <a:buNone/>
              <a:defRPr sz="630" b="1"/>
            </a:lvl2pPr>
            <a:lvl3pPr marL="288036" indent="0">
              <a:buNone/>
              <a:defRPr sz="567" b="1"/>
            </a:lvl3pPr>
            <a:lvl4pPr marL="432054" indent="0">
              <a:buNone/>
              <a:defRPr sz="504" b="1"/>
            </a:lvl4pPr>
            <a:lvl5pPr marL="576072" indent="0">
              <a:buNone/>
              <a:defRPr sz="504" b="1"/>
            </a:lvl5pPr>
            <a:lvl6pPr marL="720090" indent="0">
              <a:buNone/>
              <a:defRPr sz="504" b="1"/>
            </a:lvl6pPr>
            <a:lvl7pPr marL="864108" indent="0">
              <a:buNone/>
              <a:defRPr sz="504" b="1"/>
            </a:lvl7pPr>
            <a:lvl8pPr marL="1008126" indent="0">
              <a:buNone/>
              <a:defRPr sz="504" b="1"/>
            </a:lvl8pPr>
            <a:lvl9pPr marL="1152144" indent="0">
              <a:buNone/>
              <a:defRPr sz="504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6713" y="789215"/>
            <a:ext cx="2436517" cy="116081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915722" y="529645"/>
            <a:ext cx="2448516" cy="259570"/>
          </a:xfrm>
        </p:spPr>
        <p:txBody>
          <a:bodyPr anchor="b"/>
          <a:lstStyle>
            <a:lvl1pPr marL="0" indent="0">
              <a:buNone/>
              <a:defRPr sz="756" b="1"/>
            </a:lvl1pPr>
            <a:lvl2pPr marL="144018" indent="0">
              <a:buNone/>
              <a:defRPr sz="630" b="1"/>
            </a:lvl2pPr>
            <a:lvl3pPr marL="288036" indent="0">
              <a:buNone/>
              <a:defRPr sz="567" b="1"/>
            </a:lvl3pPr>
            <a:lvl4pPr marL="432054" indent="0">
              <a:buNone/>
              <a:defRPr sz="504" b="1"/>
            </a:lvl4pPr>
            <a:lvl5pPr marL="576072" indent="0">
              <a:buNone/>
              <a:defRPr sz="504" b="1"/>
            </a:lvl5pPr>
            <a:lvl6pPr marL="720090" indent="0">
              <a:buNone/>
              <a:defRPr sz="504" b="1"/>
            </a:lvl6pPr>
            <a:lvl7pPr marL="864108" indent="0">
              <a:buNone/>
              <a:defRPr sz="504" b="1"/>
            </a:lvl7pPr>
            <a:lvl8pPr marL="1008126" indent="0">
              <a:buNone/>
              <a:defRPr sz="504" b="1"/>
            </a:lvl8pPr>
            <a:lvl9pPr marL="1152144" indent="0">
              <a:buNone/>
              <a:defRPr sz="504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915722" y="789215"/>
            <a:ext cx="2448516" cy="116081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089A3-F22B-0A4E-8A87-485EF8273370}" type="datetimeFigureOut">
              <a:rPr kumimoji="1" lang="zh-CN" altLang="en-US" smtClean="0"/>
              <a:t>2018/9/8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95EF27-9A66-A148-9307-9C9E776C768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816131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089A3-F22B-0A4E-8A87-485EF8273370}" type="datetimeFigureOut">
              <a:rPr kumimoji="1" lang="zh-CN" altLang="en-US" smtClean="0"/>
              <a:t>2018/9/8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95EF27-9A66-A148-9307-9C9E776C768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995267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089A3-F22B-0A4E-8A87-485EF8273370}" type="datetimeFigureOut">
              <a:rPr kumimoji="1" lang="zh-CN" altLang="en-US" smtClean="0"/>
              <a:t>2018/9/8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95EF27-9A66-A148-9307-9C9E776C768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580209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3" y="144039"/>
            <a:ext cx="1857572" cy="504137"/>
          </a:xfrm>
        </p:spPr>
        <p:txBody>
          <a:bodyPr anchor="b"/>
          <a:lstStyle>
            <a:lvl1pPr>
              <a:defRPr sz="1008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48516" y="311085"/>
            <a:ext cx="2915722" cy="1535418"/>
          </a:xfrm>
        </p:spPr>
        <p:txBody>
          <a:bodyPr/>
          <a:lstStyle>
            <a:lvl1pPr>
              <a:defRPr sz="1008"/>
            </a:lvl1pPr>
            <a:lvl2pPr>
              <a:defRPr sz="882"/>
            </a:lvl2pPr>
            <a:lvl3pPr>
              <a:defRPr sz="756"/>
            </a:lvl3pPr>
            <a:lvl4pPr>
              <a:defRPr sz="630"/>
            </a:lvl4pPr>
            <a:lvl5pPr>
              <a:defRPr sz="630"/>
            </a:lvl5pPr>
            <a:lvl6pPr>
              <a:defRPr sz="630"/>
            </a:lvl6pPr>
            <a:lvl7pPr>
              <a:defRPr sz="630"/>
            </a:lvl7pPr>
            <a:lvl8pPr>
              <a:defRPr sz="630"/>
            </a:lvl8pPr>
            <a:lvl9pPr>
              <a:defRPr sz="63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96713" y="648176"/>
            <a:ext cx="1857572" cy="1200827"/>
          </a:xfrm>
        </p:spPr>
        <p:txBody>
          <a:bodyPr/>
          <a:lstStyle>
            <a:lvl1pPr marL="0" indent="0">
              <a:buNone/>
              <a:defRPr sz="504"/>
            </a:lvl1pPr>
            <a:lvl2pPr marL="144018" indent="0">
              <a:buNone/>
              <a:defRPr sz="441"/>
            </a:lvl2pPr>
            <a:lvl3pPr marL="288036" indent="0">
              <a:buNone/>
              <a:defRPr sz="378"/>
            </a:lvl3pPr>
            <a:lvl4pPr marL="432054" indent="0">
              <a:buNone/>
              <a:defRPr sz="315"/>
            </a:lvl4pPr>
            <a:lvl5pPr marL="576072" indent="0">
              <a:buNone/>
              <a:defRPr sz="315"/>
            </a:lvl5pPr>
            <a:lvl6pPr marL="720090" indent="0">
              <a:buNone/>
              <a:defRPr sz="315"/>
            </a:lvl6pPr>
            <a:lvl7pPr marL="864108" indent="0">
              <a:buNone/>
              <a:defRPr sz="315"/>
            </a:lvl7pPr>
            <a:lvl8pPr marL="1008126" indent="0">
              <a:buNone/>
              <a:defRPr sz="315"/>
            </a:lvl8pPr>
            <a:lvl9pPr marL="1152144" indent="0">
              <a:buNone/>
              <a:defRPr sz="315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089A3-F22B-0A4E-8A87-485EF8273370}" type="datetimeFigureOut">
              <a:rPr kumimoji="1" lang="zh-CN" altLang="en-US" smtClean="0"/>
              <a:t>2018/9/8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95EF27-9A66-A148-9307-9C9E776C768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774216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3" y="144039"/>
            <a:ext cx="1857572" cy="504137"/>
          </a:xfrm>
        </p:spPr>
        <p:txBody>
          <a:bodyPr anchor="b"/>
          <a:lstStyle>
            <a:lvl1pPr>
              <a:defRPr sz="1008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448516" y="311085"/>
            <a:ext cx="2915722" cy="1535418"/>
          </a:xfrm>
        </p:spPr>
        <p:txBody>
          <a:bodyPr anchor="t"/>
          <a:lstStyle>
            <a:lvl1pPr marL="0" indent="0">
              <a:buNone/>
              <a:defRPr sz="1008"/>
            </a:lvl1pPr>
            <a:lvl2pPr marL="144018" indent="0">
              <a:buNone/>
              <a:defRPr sz="882"/>
            </a:lvl2pPr>
            <a:lvl3pPr marL="288036" indent="0">
              <a:buNone/>
              <a:defRPr sz="756"/>
            </a:lvl3pPr>
            <a:lvl4pPr marL="432054" indent="0">
              <a:buNone/>
              <a:defRPr sz="630"/>
            </a:lvl4pPr>
            <a:lvl5pPr marL="576072" indent="0">
              <a:buNone/>
              <a:defRPr sz="630"/>
            </a:lvl5pPr>
            <a:lvl6pPr marL="720090" indent="0">
              <a:buNone/>
              <a:defRPr sz="630"/>
            </a:lvl6pPr>
            <a:lvl7pPr marL="864108" indent="0">
              <a:buNone/>
              <a:defRPr sz="630"/>
            </a:lvl7pPr>
            <a:lvl8pPr marL="1008126" indent="0">
              <a:buNone/>
              <a:defRPr sz="630"/>
            </a:lvl8pPr>
            <a:lvl9pPr marL="1152144" indent="0">
              <a:buNone/>
              <a:defRPr sz="630"/>
            </a:lvl9pPr>
          </a:lstStyle>
          <a:p>
            <a:r>
              <a:rPr lang="zh-CN" altLang="en-US" smtClean="0"/>
              <a:t>将图片拖动到占位符，或单击添加图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96713" y="648176"/>
            <a:ext cx="1857572" cy="1200827"/>
          </a:xfrm>
        </p:spPr>
        <p:txBody>
          <a:bodyPr/>
          <a:lstStyle>
            <a:lvl1pPr marL="0" indent="0">
              <a:buNone/>
              <a:defRPr sz="504"/>
            </a:lvl1pPr>
            <a:lvl2pPr marL="144018" indent="0">
              <a:buNone/>
              <a:defRPr sz="441"/>
            </a:lvl2pPr>
            <a:lvl3pPr marL="288036" indent="0">
              <a:buNone/>
              <a:defRPr sz="378"/>
            </a:lvl3pPr>
            <a:lvl4pPr marL="432054" indent="0">
              <a:buNone/>
              <a:defRPr sz="315"/>
            </a:lvl4pPr>
            <a:lvl5pPr marL="576072" indent="0">
              <a:buNone/>
              <a:defRPr sz="315"/>
            </a:lvl5pPr>
            <a:lvl6pPr marL="720090" indent="0">
              <a:buNone/>
              <a:defRPr sz="315"/>
            </a:lvl6pPr>
            <a:lvl7pPr marL="864108" indent="0">
              <a:buNone/>
              <a:defRPr sz="315"/>
            </a:lvl7pPr>
            <a:lvl8pPr marL="1008126" indent="0">
              <a:buNone/>
              <a:defRPr sz="315"/>
            </a:lvl8pPr>
            <a:lvl9pPr marL="1152144" indent="0">
              <a:buNone/>
              <a:defRPr sz="315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089A3-F22B-0A4E-8A87-485EF8273370}" type="datetimeFigureOut">
              <a:rPr kumimoji="1" lang="zh-CN" altLang="en-US" smtClean="0"/>
              <a:t>2018/9/8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95EF27-9A66-A148-9307-9C9E776C768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527300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95962" y="115031"/>
            <a:ext cx="4967526" cy="41761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5962" y="575157"/>
            <a:ext cx="4967526" cy="13708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95962" y="2002545"/>
            <a:ext cx="1295876" cy="1150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4089A3-F22B-0A4E-8A87-485EF8273370}" type="datetimeFigureOut">
              <a:rPr kumimoji="1" lang="zh-CN" altLang="en-US" smtClean="0"/>
              <a:t>2018/9/8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907818" y="2002545"/>
            <a:ext cx="1943814" cy="1150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067612" y="2002545"/>
            <a:ext cx="1295876" cy="1150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95EF27-9A66-A148-9307-9C9E776C768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325473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288036" rtl="0" eaLnBrk="1" latinLnBrk="0" hangingPunct="1">
        <a:lnSpc>
          <a:spcPct val="90000"/>
        </a:lnSpc>
        <a:spcBef>
          <a:spcPct val="0"/>
        </a:spcBef>
        <a:buNone/>
        <a:defRPr sz="138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2009" indent="-72009" algn="l" defTabSz="288036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882" kern="1200">
          <a:solidFill>
            <a:schemeClr val="tx1"/>
          </a:solidFill>
          <a:latin typeface="+mn-lt"/>
          <a:ea typeface="+mn-ea"/>
          <a:cs typeface="+mn-cs"/>
        </a:defRPr>
      </a:lvl1pPr>
      <a:lvl2pPr marL="216027" indent="-72009" algn="l" defTabSz="288036" rtl="0" eaLnBrk="1" latinLnBrk="0" hangingPunct="1">
        <a:lnSpc>
          <a:spcPct val="90000"/>
        </a:lnSpc>
        <a:spcBef>
          <a:spcPts val="158"/>
        </a:spcBef>
        <a:buFont typeface="Arial" panose="020B0604020202020204" pitchFamily="34" charset="0"/>
        <a:buChar char="•"/>
        <a:defRPr sz="756" kern="1200">
          <a:solidFill>
            <a:schemeClr val="tx1"/>
          </a:solidFill>
          <a:latin typeface="+mn-lt"/>
          <a:ea typeface="+mn-ea"/>
          <a:cs typeface="+mn-cs"/>
        </a:defRPr>
      </a:lvl2pPr>
      <a:lvl3pPr marL="360045" indent="-72009" algn="l" defTabSz="288036" rtl="0" eaLnBrk="1" latinLnBrk="0" hangingPunct="1">
        <a:lnSpc>
          <a:spcPct val="90000"/>
        </a:lnSpc>
        <a:spcBef>
          <a:spcPts val="158"/>
        </a:spcBef>
        <a:buFont typeface="Arial" panose="020B0604020202020204" pitchFamily="34" charset="0"/>
        <a:buChar char="•"/>
        <a:defRPr sz="630" kern="1200">
          <a:solidFill>
            <a:schemeClr val="tx1"/>
          </a:solidFill>
          <a:latin typeface="+mn-lt"/>
          <a:ea typeface="+mn-ea"/>
          <a:cs typeface="+mn-cs"/>
        </a:defRPr>
      </a:lvl3pPr>
      <a:lvl4pPr marL="504063" indent="-72009" algn="l" defTabSz="288036" rtl="0" eaLnBrk="1" latinLnBrk="0" hangingPunct="1">
        <a:lnSpc>
          <a:spcPct val="90000"/>
        </a:lnSpc>
        <a:spcBef>
          <a:spcPts val="158"/>
        </a:spcBef>
        <a:buFont typeface="Arial" panose="020B0604020202020204" pitchFamily="34" charset="0"/>
        <a:buChar char="•"/>
        <a:defRPr sz="567" kern="1200">
          <a:solidFill>
            <a:schemeClr val="tx1"/>
          </a:solidFill>
          <a:latin typeface="+mn-lt"/>
          <a:ea typeface="+mn-ea"/>
          <a:cs typeface="+mn-cs"/>
        </a:defRPr>
      </a:lvl4pPr>
      <a:lvl5pPr marL="648081" indent="-72009" algn="l" defTabSz="288036" rtl="0" eaLnBrk="1" latinLnBrk="0" hangingPunct="1">
        <a:lnSpc>
          <a:spcPct val="90000"/>
        </a:lnSpc>
        <a:spcBef>
          <a:spcPts val="158"/>
        </a:spcBef>
        <a:buFont typeface="Arial" panose="020B0604020202020204" pitchFamily="34" charset="0"/>
        <a:buChar char="•"/>
        <a:defRPr sz="567" kern="1200">
          <a:solidFill>
            <a:schemeClr val="tx1"/>
          </a:solidFill>
          <a:latin typeface="+mn-lt"/>
          <a:ea typeface="+mn-ea"/>
          <a:cs typeface="+mn-cs"/>
        </a:defRPr>
      </a:lvl5pPr>
      <a:lvl6pPr marL="792099" indent="-72009" algn="l" defTabSz="288036" rtl="0" eaLnBrk="1" latinLnBrk="0" hangingPunct="1">
        <a:lnSpc>
          <a:spcPct val="90000"/>
        </a:lnSpc>
        <a:spcBef>
          <a:spcPts val="158"/>
        </a:spcBef>
        <a:buFont typeface="Arial" panose="020B0604020202020204" pitchFamily="34" charset="0"/>
        <a:buChar char="•"/>
        <a:defRPr sz="567" kern="1200">
          <a:solidFill>
            <a:schemeClr val="tx1"/>
          </a:solidFill>
          <a:latin typeface="+mn-lt"/>
          <a:ea typeface="+mn-ea"/>
          <a:cs typeface="+mn-cs"/>
        </a:defRPr>
      </a:lvl6pPr>
      <a:lvl7pPr marL="936117" indent="-72009" algn="l" defTabSz="288036" rtl="0" eaLnBrk="1" latinLnBrk="0" hangingPunct="1">
        <a:lnSpc>
          <a:spcPct val="90000"/>
        </a:lnSpc>
        <a:spcBef>
          <a:spcPts val="158"/>
        </a:spcBef>
        <a:buFont typeface="Arial" panose="020B0604020202020204" pitchFamily="34" charset="0"/>
        <a:buChar char="•"/>
        <a:defRPr sz="567" kern="1200">
          <a:solidFill>
            <a:schemeClr val="tx1"/>
          </a:solidFill>
          <a:latin typeface="+mn-lt"/>
          <a:ea typeface="+mn-ea"/>
          <a:cs typeface="+mn-cs"/>
        </a:defRPr>
      </a:lvl7pPr>
      <a:lvl8pPr marL="1080135" indent="-72009" algn="l" defTabSz="288036" rtl="0" eaLnBrk="1" latinLnBrk="0" hangingPunct="1">
        <a:lnSpc>
          <a:spcPct val="90000"/>
        </a:lnSpc>
        <a:spcBef>
          <a:spcPts val="158"/>
        </a:spcBef>
        <a:buFont typeface="Arial" panose="020B0604020202020204" pitchFamily="34" charset="0"/>
        <a:buChar char="•"/>
        <a:defRPr sz="567" kern="1200">
          <a:solidFill>
            <a:schemeClr val="tx1"/>
          </a:solidFill>
          <a:latin typeface="+mn-lt"/>
          <a:ea typeface="+mn-ea"/>
          <a:cs typeface="+mn-cs"/>
        </a:defRPr>
      </a:lvl8pPr>
      <a:lvl9pPr marL="1224153" indent="-72009" algn="l" defTabSz="288036" rtl="0" eaLnBrk="1" latinLnBrk="0" hangingPunct="1">
        <a:lnSpc>
          <a:spcPct val="90000"/>
        </a:lnSpc>
        <a:spcBef>
          <a:spcPts val="158"/>
        </a:spcBef>
        <a:buFont typeface="Arial" panose="020B0604020202020204" pitchFamily="34" charset="0"/>
        <a:buChar char="•"/>
        <a:defRPr sz="5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88036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1pPr>
      <a:lvl2pPr marL="144018" algn="l" defTabSz="288036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2pPr>
      <a:lvl3pPr marL="288036" algn="l" defTabSz="288036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3pPr>
      <a:lvl4pPr marL="432054" algn="l" defTabSz="288036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4pPr>
      <a:lvl5pPr marL="576072" algn="l" defTabSz="288036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5pPr>
      <a:lvl6pPr marL="720090" algn="l" defTabSz="288036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6pPr>
      <a:lvl7pPr marL="864108" algn="l" defTabSz="288036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7pPr>
      <a:lvl8pPr marL="1008126" algn="l" defTabSz="288036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8pPr>
      <a:lvl9pPr marL="1152144" algn="l" defTabSz="288036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38046833"/>
              </p:ext>
            </p:extLst>
          </p:nvPr>
        </p:nvGraphicFramePr>
        <p:xfrm>
          <a:off x="156453" y="95564"/>
          <a:ext cx="5358253" cy="197104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87574"/>
                <a:gridCol w="806641"/>
                <a:gridCol w="3664038"/>
              </a:tblGrid>
              <a:tr h="334532">
                <a:tc>
                  <a:txBody>
                    <a:bodyPr/>
                    <a:lstStyle/>
                    <a:p>
                      <a:pPr marL="0" algn="ctr" defTabSz="684063" rtl="0" eaLnBrk="1" latinLnBrk="0" hangingPunct="1"/>
                      <a:r>
                        <a:rPr lang="en-US" altLang="zh-CN" sz="1000" b="0" kern="1200" dirty="0" smtClean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Cell type</a:t>
                      </a:r>
                      <a:endParaRPr lang="zh-CN" altLang="en-US" sz="1000" b="0" kern="1200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Data type</a:t>
                      </a:r>
                      <a:endParaRPr lang="zh-CN" altLang="en-US" sz="1000" b="0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0" dirty="0" smtClean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Link</a:t>
                      </a:r>
                      <a:endParaRPr lang="zh-CN" altLang="en-US" sz="1000" b="0" dirty="0" smtClean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02282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H1-hESC</a:t>
                      </a:r>
                      <a:endParaRPr lang="zh-CN" altLang="en-US" sz="1000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68406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dirty="0" smtClean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HM450K</a:t>
                      </a:r>
                      <a:endParaRPr lang="zh-CN" altLang="en-US" sz="1000" dirty="0" smtClean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https://</a:t>
                      </a:r>
                      <a:r>
                        <a:rPr lang="en-US" altLang="zh-CN" sz="1000" dirty="0" err="1" smtClean="0">
                          <a:latin typeface="Arial" charset="0"/>
                          <a:ea typeface="Arial" charset="0"/>
                          <a:cs typeface="Arial" charset="0"/>
                        </a:rPr>
                        <a:t>www.encodeproject.org</a:t>
                      </a:r>
                      <a:r>
                        <a:rPr lang="en-US" altLang="zh-CN" sz="10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/experiments/ENCSR000ABI/</a:t>
                      </a:r>
                      <a:endParaRPr lang="zh-CN" altLang="en-US" sz="10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02282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H1-hESC</a:t>
                      </a:r>
                      <a:endParaRPr lang="zh-CN" altLang="en-US" sz="1000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WGBS</a:t>
                      </a:r>
                      <a:endParaRPr lang="zh-CN" altLang="en-US" sz="1000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 smtClean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https://</a:t>
                      </a:r>
                      <a:r>
                        <a:rPr lang="en-US" altLang="zh-CN" sz="1000" dirty="0" err="1" smtClean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www.encodeproject.org</a:t>
                      </a:r>
                      <a:r>
                        <a:rPr lang="en-US" altLang="zh-CN" sz="1000" dirty="0" smtClean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/experiments/ENCSR617FKV/</a:t>
                      </a:r>
                      <a:endParaRPr lang="zh-CN" altLang="en-US" sz="1000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02282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GM12878</a:t>
                      </a:r>
                      <a:endParaRPr lang="zh-CN" altLang="en-US" sz="1000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HM450K</a:t>
                      </a:r>
                      <a:endParaRPr lang="zh-CN" altLang="en-US" sz="1000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https://</a:t>
                      </a:r>
                      <a:r>
                        <a:rPr lang="en-US" altLang="zh-CN" sz="1000" dirty="0" err="1" smtClean="0">
                          <a:latin typeface="Arial" charset="0"/>
                          <a:ea typeface="Arial" charset="0"/>
                          <a:cs typeface="Arial" charset="0"/>
                        </a:rPr>
                        <a:t>www.encodeproject.org</a:t>
                      </a:r>
                      <a:r>
                        <a:rPr lang="en-US" altLang="zh-CN" sz="10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/experiments/ENCSR000ACX/</a:t>
                      </a:r>
                      <a:endParaRPr lang="zh-CN" altLang="en-US" sz="10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64835">
                <a:tc>
                  <a:txBody>
                    <a:bodyPr/>
                    <a:lstStyle/>
                    <a:p>
                      <a:pPr marL="0" marR="0" indent="0" algn="ctr" defTabSz="68406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dirty="0" smtClean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GM12878</a:t>
                      </a:r>
                      <a:endParaRPr lang="zh-CN" altLang="en-US" sz="1000" dirty="0" smtClean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68406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dirty="0" smtClean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EPIC</a:t>
                      </a:r>
                      <a:endParaRPr lang="zh-CN" altLang="en-US" sz="1000" dirty="0" smtClean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 smtClean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https://</a:t>
                      </a:r>
                      <a:r>
                        <a:rPr lang="en-US" altLang="zh-CN" sz="1000" dirty="0" err="1" smtClean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www.encodeproject.org</a:t>
                      </a:r>
                      <a:r>
                        <a:rPr lang="en-US" altLang="zh-CN" sz="1000" dirty="0" smtClean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/experiments/ENCSR135FMA/</a:t>
                      </a:r>
                      <a:endParaRPr lang="zh-CN" altLang="en-US" sz="1000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64835">
                <a:tc>
                  <a:txBody>
                    <a:bodyPr/>
                    <a:lstStyle/>
                    <a:p>
                      <a:pPr marL="0" marR="0" indent="0" algn="ctr" defTabSz="68406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dirty="0" smtClean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GM12878</a:t>
                      </a:r>
                      <a:endParaRPr lang="zh-CN" altLang="en-US" sz="1000" dirty="0" smtClean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68406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dirty="0" smtClean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WGBS</a:t>
                      </a:r>
                      <a:endParaRPr lang="zh-CN" altLang="en-US" sz="1000" dirty="0" smtClean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https://</a:t>
                      </a:r>
                      <a:r>
                        <a:rPr lang="en-US" altLang="zh-CN" sz="1000" dirty="0" err="1" smtClean="0">
                          <a:latin typeface="Arial" charset="0"/>
                          <a:ea typeface="Arial" charset="0"/>
                          <a:cs typeface="Arial" charset="0"/>
                        </a:rPr>
                        <a:t>www.encodeproject.org</a:t>
                      </a:r>
                      <a:r>
                        <a:rPr lang="en-US" altLang="zh-CN" sz="10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/experiments/ENCSR890UQO/</a:t>
                      </a:r>
                      <a:endParaRPr lang="zh-CN" altLang="en-US" sz="10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980885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35</Words>
  <Application>Microsoft Macintosh PowerPoint</Application>
  <PresentationFormat>自定义</PresentationFormat>
  <Paragraphs>1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宋体</vt:lpstr>
      <vt:lpstr>Arial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用户</dc:creator>
  <cp:lastModifiedBy>Microsoft Office 用户</cp:lastModifiedBy>
  <cp:revision>7</cp:revision>
  <dcterms:created xsi:type="dcterms:W3CDTF">2018-02-12T02:15:18Z</dcterms:created>
  <dcterms:modified xsi:type="dcterms:W3CDTF">2018-09-08T19:18:47Z</dcterms:modified>
</cp:coreProperties>
</file>